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64" d="100"/>
          <a:sy n="64" d="100"/>
        </p:scale>
        <p:origin x="6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F04BA-92D7-4F43-A135-EE5C0719F6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15F4D5-43D3-412E-AA71-1064DA9BC6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FC6928-ABF1-49CE-9A62-53EF26F42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E15192-DA1B-46A0-9983-268CEAFBA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202D7-B164-4BA5-A496-D38CCFD84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774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A0D75A-C201-483E-B4F4-451960E601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9B0D9E-C033-4676-A4D3-C863576C63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9A794F-BA15-4506-A0E6-50765EA46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791D5-BB91-414E-BE2B-3E901CC2E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CFEF17-C2C1-4EA9-81A2-4181BAEAE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128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8FD8DB-A3C0-4B25-9893-F75893A4A5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052312-C5E3-4474-8D4D-64DB53595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9B135D-B40E-4537-AC75-EADE85DA9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FB98D7-3F6C-4811-B084-564DA0AFF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2FA3C5-290F-46A8-8CEB-182C579E8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905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1F022-8991-4408-96C3-BCE3DE735C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BD6F64-09E1-4A95-A02C-0DC2DEC2D8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27D0F-05FB-4303-B227-6937056CD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21E698-0A4F-487B-B707-162D52576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760157-F953-45AB-829A-69D7DBAAD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545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9F7041-3D1A-4B76-AFBB-D724D96451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CA52D5-806C-414F-ACEC-80578BE75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B53A7-6103-4405-91FF-F7E32D31A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546AA2-83E9-4C24-A0ED-AFBD475B8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739F26-864C-4668-8227-945E56CB9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303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80198-85D3-46E9-8CC3-747E1D9FA6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DE018A-570E-4E76-A7E4-5D8AA81E73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16B848-8F9C-4CCC-BB96-97933DF6D1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72ABB7-55DA-4BBD-8714-FB1DF4BD1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B31910-20F8-433C-A778-5DEFAB3E5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0734A5-91FE-4F83-9F92-94F4A9A1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453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5AE97-4719-4DD0-8520-6F43FD8D39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4B0656-B2CB-4BF4-BE5F-8109B576B5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7AC3AD-9140-4378-BF75-4CF094DE39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E62D2F-1C3D-4DFB-A76E-552EE708E3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6A41FF-8B83-4001-B0A6-3B0DD12774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AC2490-95D8-4769-9806-7B879D577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1F2305-CAA1-4A70-810C-E1599004A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ACFF315-A202-4383-8E37-AA4C6EE47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90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C5B90A-9E0E-40D1-94E0-89C7F8899C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66196A-1995-438E-A255-9265B5C30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B85B47-E229-4CF7-9473-C8BE03F76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E58386-534A-4DCC-894A-6F96ABED0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049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588F8D-6543-42BD-AED8-0F2CC198C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44E644-6504-475B-A60A-07AA17705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438B41-C318-4AEE-9381-884FB8F03D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87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BA828-1D85-4102-A357-7D18C4B1A9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E42F8A-2161-465E-ACB1-5CB606155E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6FE-A5D5-4D0C-B9A4-1968E9834F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4095EC-BA69-46B4-BB7E-9A871D7B0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903ED6-36EB-4DF5-8E36-977A26459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D731C5-7684-43D3-9323-784A1872D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27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5730A-E3EE-4B79-8A89-180BBD8F66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28733B-24E4-4C48-83DC-86BD47000A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18416A-2503-49CC-A209-D4EF264E39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EFC939-C438-4E35-AAB5-57C309F6C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649DA9-FD8A-43DF-8DFC-113D7BC99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ED15D7-D733-4782-BD46-452697F59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716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969B478-35D5-4038-9F66-91458E7FD0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B47E6C-1796-4113-998A-4D15AA2B43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288AB4-7DC5-4CD6-9B4B-DAA7D6CD8B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29931-205A-4710-8F57-59B0577CA3C2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A88A57-C8FF-427A-A730-B51F100FB9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5055C-C712-4BBE-8EAD-ED5E7D9FC6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2D54E2-2B77-49D0-A62A-09FA3EC7B4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09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7" Type="http://schemas.openxmlformats.org/officeDocument/2006/relationships/image" Target="../media/image14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F0FF28C-C580-47AC-857A-F9FDC95FA1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830" y="4793126"/>
            <a:ext cx="3400044" cy="178155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A4595CD-0F4E-487F-B012-A920558B44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830" y="406000"/>
            <a:ext cx="3400044" cy="178155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19D48D3-4B9E-4E2C-8845-8805E71DDFC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3897" y="4793126"/>
            <a:ext cx="3258312" cy="144627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8010C71-A8B9-4996-94B0-5B15B7FAC76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8586" y="2566797"/>
            <a:ext cx="3529584" cy="19507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1FBFC40-E061-4F29-A1E5-76955181AE5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8586" y="406000"/>
            <a:ext cx="3425952" cy="174345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F56C139-9B08-4FEC-B687-7330A799DDC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3897" y="406000"/>
            <a:ext cx="3310128" cy="188518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4964B87-E942-4C15-98F0-87E0CD7CD68B}"/>
              </a:ext>
            </a:extLst>
          </p:cNvPr>
          <p:cNvSpPr txBox="1"/>
          <p:nvPr/>
        </p:nvSpPr>
        <p:spPr>
          <a:xfrm>
            <a:off x="1255305" y="1135026"/>
            <a:ext cx="1398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(Ser473)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135507B-19B7-472E-897E-9C871AFBE575}"/>
              </a:ext>
            </a:extLst>
          </p:cNvPr>
          <p:cNvSpPr/>
          <p:nvPr/>
        </p:nvSpPr>
        <p:spPr>
          <a:xfrm>
            <a:off x="914793" y="1563369"/>
            <a:ext cx="2498528" cy="3205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Arrow: Right 21">
            <a:extLst>
              <a:ext uri="{FF2B5EF4-FFF2-40B4-BE49-F238E27FC236}">
                <a16:creationId xmlns:a16="http://schemas.microsoft.com/office/drawing/2014/main" id="{77700BD8-DBEC-4D63-9743-1F99AD6E0242}"/>
              </a:ext>
            </a:extLst>
          </p:cNvPr>
          <p:cNvSpPr/>
          <p:nvPr/>
        </p:nvSpPr>
        <p:spPr>
          <a:xfrm rot="5400000">
            <a:off x="1083432" y="1258398"/>
            <a:ext cx="231398" cy="1123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4CBB47C-025F-4CE0-A18B-1377586FFF4A}"/>
              </a:ext>
            </a:extLst>
          </p:cNvPr>
          <p:cNvSpPr txBox="1"/>
          <p:nvPr/>
        </p:nvSpPr>
        <p:spPr>
          <a:xfrm>
            <a:off x="5056916" y="1253442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1C3B580B-9B6C-4551-872E-94C5015CA961}"/>
              </a:ext>
            </a:extLst>
          </p:cNvPr>
          <p:cNvSpPr/>
          <p:nvPr/>
        </p:nvSpPr>
        <p:spPr>
          <a:xfrm>
            <a:off x="4724792" y="1654375"/>
            <a:ext cx="2523295" cy="3897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Arrow: Right 24">
            <a:extLst>
              <a:ext uri="{FF2B5EF4-FFF2-40B4-BE49-F238E27FC236}">
                <a16:creationId xmlns:a16="http://schemas.microsoft.com/office/drawing/2014/main" id="{5B99733D-C094-4FE3-AE3A-40740B1A02D7}"/>
              </a:ext>
            </a:extLst>
          </p:cNvPr>
          <p:cNvSpPr/>
          <p:nvPr/>
        </p:nvSpPr>
        <p:spPr>
          <a:xfrm rot="5400000">
            <a:off x="4885043" y="1376814"/>
            <a:ext cx="231398" cy="1123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1B2DDEA-561C-4990-92D0-ABB37ADFA989}"/>
              </a:ext>
            </a:extLst>
          </p:cNvPr>
          <p:cNvSpPr txBox="1"/>
          <p:nvPr/>
        </p:nvSpPr>
        <p:spPr>
          <a:xfrm>
            <a:off x="8824316" y="945665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oxO1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FAB5ECA-056D-4D30-A9E5-87C5BA6EC94D}"/>
              </a:ext>
            </a:extLst>
          </p:cNvPr>
          <p:cNvSpPr/>
          <p:nvPr/>
        </p:nvSpPr>
        <p:spPr>
          <a:xfrm>
            <a:off x="8525748" y="1346598"/>
            <a:ext cx="2523295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Arrow: Right 27">
            <a:extLst>
              <a:ext uri="{FF2B5EF4-FFF2-40B4-BE49-F238E27FC236}">
                <a16:creationId xmlns:a16="http://schemas.microsoft.com/office/drawing/2014/main" id="{C401CD34-B29D-4A6F-A980-05E2CB68F462}"/>
              </a:ext>
            </a:extLst>
          </p:cNvPr>
          <p:cNvSpPr/>
          <p:nvPr/>
        </p:nvSpPr>
        <p:spPr>
          <a:xfrm rot="5400000">
            <a:off x="8652443" y="1069037"/>
            <a:ext cx="231398" cy="1123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E612697F-829D-4D7B-9CDE-20D4CF6F53A0}"/>
              </a:ext>
            </a:extLst>
          </p:cNvPr>
          <p:cNvGrpSpPr/>
          <p:nvPr/>
        </p:nvGrpSpPr>
        <p:grpSpPr>
          <a:xfrm>
            <a:off x="4273897" y="2514981"/>
            <a:ext cx="3218688" cy="1705356"/>
            <a:chOff x="543830" y="2566797"/>
            <a:chExt cx="3218688" cy="170535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5846ABF-2580-49A7-882C-2EA2FFDA457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830" y="2566797"/>
              <a:ext cx="3218688" cy="1705356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B261131-8005-423A-82FB-3821EC8EFE0B}"/>
                </a:ext>
              </a:extLst>
            </p:cNvPr>
            <p:cNvSpPr txBox="1"/>
            <p:nvPr/>
          </p:nvSpPr>
          <p:spPr>
            <a:xfrm>
              <a:off x="1390927" y="3267228"/>
              <a:ext cx="720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TOR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2E98ADC6-63B2-4C23-85CE-FB8E5AE91FFF}"/>
                </a:ext>
              </a:extLst>
            </p:cNvPr>
            <p:cNvSpPr/>
            <p:nvPr/>
          </p:nvSpPr>
          <p:spPr>
            <a:xfrm>
              <a:off x="1050415" y="3657600"/>
              <a:ext cx="2498528" cy="3907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Arrow: Right 30">
              <a:extLst>
                <a:ext uri="{FF2B5EF4-FFF2-40B4-BE49-F238E27FC236}">
                  <a16:creationId xmlns:a16="http://schemas.microsoft.com/office/drawing/2014/main" id="{67846F20-5424-4E1B-B28E-0C2C0D6C8F55}"/>
                </a:ext>
              </a:extLst>
            </p:cNvPr>
            <p:cNvSpPr/>
            <p:nvPr/>
          </p:nvSpPr>
          <p:spPr>
            <a:xfrm rot="5400000">
              <a:off x="1219054" y="3390600"/>
              <a:ext cx="231398" cy="112347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F398C02A-FDD4-4D0E-BDE6-3D274DED8BB0}"/>
              </a:ext>
            </a:extLst>
          </p:cNvPr>
          <p:cNvGrpSpPr/>
          <p:nvPr/>
        </p:nvGrpSpPr>
        <p:grpSpPr>
          <a:xfrm>
            <a:off x="543830" y="2514981"/>
            <a:ext cx="3400044" cy="1950720"/>
            <a:chOff x="4240530" y="2566797"/>
            <a:chExt cx="3400044" cy="1950720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C7834ECA-7E7D-4923-B2C6-4A5417EDCA8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0530" y="2566797"/>
              <a:ext cx="3400044" cy="195072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248275E-B29E-4D6C-9593-79FAB6F73716}"/>
                </a:ext>
              </a:extLst>
            </p:cNvPr>
            <p:cNvSpPr txBox="1"/>
            <p:nvPr/>
          </p:nvSpPr>
          <p:spPr>
            <a:xfrm>
              <a:off x="5285080" y="3207916"/>
              <a:ext cx="8995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-mTOR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EE4382DF-CD9F-499B-AF11-097DB37376CB}"/>
                </a:ext>
              </a:extLst>
            </p:cNvPr>
            <p:cNvSpPr/>
            <p:nvPr/>
          </p:nvSpPr>
          <p:spPr>
            <a:xfrm>
              <a:off x="4944568" y="3589899"/>
              <a:ext cx="2498528" cy="39077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Arrow: Right 33">
              <a:extLst>
                <a:ext uri="{FF2B5EF4-FFF2-40B4-BE49-F238E27FC236}">
                  <a16:creationId xmlns:a16="http://schemas.microsoft.com/office/drawing/2014/main" id="{8C986CF6-8F54-4F1C-B785-DE99D1D2E6E4}"/>
                </a:ext>
              </a:extLst>
            </p:cNvPr>
            <p:cNvSpPr/>
            <p:nvPr/>
          </p:nvSpPr>
          <p:spPr>
            <a:xfrm rot="5400000">
              <a:off x="5113207" y="3331288"/>
              <a:ext cx="231398" cy="112347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81B2C5AD-5AF4-4EAA-AF07-FE78D1FB5C50}"/>
              </a:ext>
            </a:extLst>
          </p:cNvPr>
          <p:cNvSpPr txBox="1"/>
          <p:nvPr/>
        </p:nvSpPr>
        <p:spPr>
          <a:xfrm>
            <a:off x="8930048" y="3374990"/>
            <a:ext cx="9476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3FA8E50-8DA9-451A-A0C3-FC342767C08A}"/>
              </a:ext>
            </a:extLst>
          </p:cNvPr>
          <p:cNvSpPr/>
          <p:nvPr/>
        </p:nvSpPr>
        <p:spPr>
          <a:xfrm>
            <a:off x="8685124" y="3785285"/>
            <a:ext cx="2498528" cy="3907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Arrow: Right 36">
            <a:extLst>
              <a:ext uri="{FF2B5EF4-FFF2-40B4-BE49-F238E27FC236}">
                <a16:creationId xmlns:a16="http://schemas.microsoft.com/office/drawing/2014/main" id="{350B3C33-6166-4453-BD58-838D3AEE6E2C}"/>
              </a:ext>
            </a:extLst>
          </p:cNvPr>
          <p:cNvSpPr/>
          <p:nvPr/>
        </p:nvSpPr>
        <p:spPr>
          <a:xfrm rot="5400000">
            <a:off x="8758175" y="3498362"/>
            <a:ext cx="231398" cy="1123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CB51439-7E3A-426A-9145-C03157DC6294}"/>
              </a:ext>
            </a:extLst>
          </p:cNvPr>
          <p:cNvSpPr txBox="1"/>
          <p:nvPr/>
        </p:nvSpPr>
        <p:spPr>
          <a:xfrm>
            <a:off x="1532206" y="5660199"/>
            <a:ext cx="10518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-PRAS40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C56DCC41-E887-417F-A82F-CF643058733B}"/>
              </a:ext>
            </a:extLst>
          </p:cNvPr>
          <p:cNvSpPr/>
          <p:nvPr/>
        </p:nvSpPr>
        <p:spPr>
          <a:xfrm>
            <a:off x="1238658" y="5204222"/>
            <a:ext cx="2498528" cy="3907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Arrow: Right 41">
            <a:extLst>
              <a:ext uri="{FF2B5EF4-FFF2-40B4-BE49-F238E27FC236}">
                <a16:creationId xmlns:a16="http://schemas.microsoft.com/office/drawing/2014/main" id="{71C434DC-6669-4DB5-90C9-916D111785D6}"/>
              </a:ext>
            </a:extLst>
          </p:cNvPr>
          <p:cNvSpPr/>
          <p:nvPr/>
        </p:nvSpPr>
        <p:spPr>
          <a:xfrm rot="16200000">
            <a:off x="1368463" y="5759077"/>
            <a:ext cx="231398" cy="1123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5CA8E8E-E842-426D-9F83-4BE126735DC9}"/>
              </a:ext>
            </a:extLst>
          </p:cNvPr>
          <p:cNvSpPr txBox="1"/>
          <p:nvPr/>
        </p:nvSpPr>
        <p:spPr>
          <a:xfrm>
            <a:off x="4932250" y="5540712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AS40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0B9D56D2-EEFE-426A-9F99-3780A02B922D}"/>
              </a:ext>
            </a:extLst>
          </p:cNvPr>
          <p:cNvSpPr/>
          <p:nvPr/>
        </p:nvSpPr>
        <p:spPr>
          <a:xfrm>
            <a:off x="4638702" y="5087360"/>
            <a:ext cx="2498528" cy="3907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Arrow: Right 44">
            <a:extLst>
              <a:ext uri="{FF2B5EF4-FFF2-40B4-BE49-F238E27FC236}">
                <a16:creationId xmlns:a16="http://schemas.microsoft.com/office/drawing/2014/main" id="{E8D471CD-8973-44C8-9C16-640241D36F3D}"/>
              </a:ext>
            </a:extLst>
          </p:cNvPr>
          <p:cNvSpPr/>
          <p:nvPr/>
        </p:nvSpPr>
        <p:spPr>
          <a:xfrm rot="16200000">
            <a:off x="4768507" y="5642215"/>
            <a:ext cx="231398" cy="1123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440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87C3697-7818-4EAE-AD16-3CB587A17BD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890" y="488476"/>
            <a:ext cx="3517392" cy="157581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047CD50-0478-4402-8159-43E9C292C45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92" t="-1" r="-1" b="-2016"/>
          <a:stretch/>
        </p:blipFill>
        <p:spPr>
          <a:xfrm rot="21194696">
            <a:off x="4065573" y="244806"/>
            <a:ext cx="3583215" cy="187034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D7CE5A7-5F5B-4856-88AC-89DE185755A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1199876">
            <a:off x="8204756" y="383321"/>
            <a:ext cx="3569208" cy="192481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C5D7CF5-74CE-4B68-9DA5-70C5E0D0AFCA}"/>
              </a:ext>
            </a:extLst>
          </p:cNvPr>
          <p:cNvSpPr txBox="1"/>
          <p:nvPr/>
        </p:nvSpPr>
        <p:spPr>
          <a:xfrm>
            <a:off x="722023" y="857808"/>
            <a:ext cx="9573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48A6503-0CA9-4148-8D5A-2BF045BA8C8F}"/>
              </a:ext>
            </a:extLst>
          </p:cNvPr>
          <p:cNvSpPr txBox="1"/>
          <p:nvPr/>
        </p:nvSpPr>
        <p:spPr>
          <a:xfrm>
            <a:off x="4526937" y="1054242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5A6F3C9-C565-493A-8FC1-DA96F64B05A2}"/>
              </a:ext>
            </a:extLst>
          </p:cNvPr>
          <p:cNvSpPr/>
          <p:nvPr/>
        </p:nvSpPr>
        <p:spPr>
          <a:xfrm>
            <a:off x="470929" y="1222806"/>
            <a:ext cx="1414846" cy="29037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C30AF25-B367-465E-B529-0648453624E6}"/>
              </a:ext>
            </a:extLst>
          </p:cNvPr>
          <p:cNvSpPr/>
          <p:nvPr/>
        </p:nvSpPr>
        <p:spPr>
          <a:xfrm>
            <a:off x="4263918" y="1430792"/>
            <a:ext cx="1414846" cy="27264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4B3FB5B-CBB6-4139-81CC-2ADF1B903388}"/>
              </a:ext>
            </a:extLst>
          </p:cNvPr>
          <p:cNvSpPr/>
          <p:nvPr/>
        </p:nvSpPr>
        <p:spPr>
          <a:xfrm>
            <a:off x="8752347" y="765855"/>
            <a:ext cx="1414846" cy="24584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FD51ED3-BB26-4439-9E0B-B1BADBFD25C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038442">
            <a:off x="320831" y="3958864"/>
            <a:ext cx="3710940" cy="1795272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7F4F560F-17F5-408B-ACB0-0F7AFB7D9C07}"/>
              </a:ext>
            </a:extLst>
          </p:cNvPr>
          <p:cNvSpPr/>
          <p:nvPr/>
        </p:nvSpPr>
        <p:spPr>
          <a:xfrm>
            <a:off x="1178352" y="5120890"/>
            <a:ext cx="1379031" cy="26240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0EA59FE-D04D-4A91-B9A8-DABC295592C6}"/>
              </a:ext>
            </a:extLst>
          </p:cNvPr>
          <p:cNvSpPr txBox="1"/>
          <p:nvPr/>
        </p:nvSpPr>
        <p:spPr>
          <a:xfrm>
            <a:off x="8888651" y="421552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P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5F478AC-0C25-47A6-AA41-C6E84384E03E}"/>
              </a:ext>
            </a:extLst>
          </p:cNvPr>
          <p:cNvSpPr txBox="1"/>
          <p:nvPr/>
        </p:nvSpPr>
        <p:spPr>
          <a:xfrm>
            <a:off x="1246862" y="4740117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C1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F6D7D2E4-5452-4F5D-930D-AC893910050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27279">
            <a:off x="4736702" y="4234918"/>
            <a:ext cx="3322320" cy="1420368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7CD0435D-133E-4691-976F-CBCAE0CC9F02}"/>
              </a:ext>
            </a:extLst>
          </p:cNvPr>
          <p:cNvSpPr/>
          <p:nvPr/>
        </p:nvSpPr>
        <p:spPr>
          <a:xfrm>
            <a:off x="5118847" y="5216886"/>
            <a:ext cx="1281953" cy="26240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D9BFEBC-6299-4654-9F6C-1AFA51065217}"/>
              </a:ext>
            </a:extLst>
          </p:cNvPr>
          <p:cNvSpPr txBox="1"/>
          <p:nvPr/>
        </p:nvSpPr>
        <p:spPr>
          <a:xfrm>
            <a:off x="5040544" y="4730440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-ACC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54FDDBD-A63E-44C7-9DCC-EEC1BE2A39FC}"/>
              </a:ext>
            </a:extLst>
          </p:cNvPr>
          <p:cNvSpPr txBox="1"/>
          <p:nvPr/>
        </p:nvSpPr>
        <p:spPr>
          <a:xfrm>
            <a:off x="583468" y="155410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26576F9-4C18-4DD0-80D3-3029C74DD1BB}"/>
              </a:ext>
            </a:extLst>
          </p:cNvPr>
          <p:cNvSpPr txBox="1"/>
          <p:nvPr/>
        </p:nvSpPr>
        <p:spPr>
          <a:xfrm>
            <a:off x="1154000" y="1549552"/>
            <a:ext cx="580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UR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995EFF02-EFC8-4027-A955-5C7E3FFD079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171605">
            <a:off x="8739454" y="4049143"/>
            <a:ext cx="3116580" cy="2066544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B0D3C9FF-4BBE-4BBA-8676-5BCEB3710C58}"/>
              </a:ext>
            </a:extLst>
          </p:cNvPr>
          <p:cNvSpPr/>
          <p:nvPr/>
        </p:nvSpPr>
        <p:spPr>
          <a:xfrm>
            <a:off x="8955742" y="5432041"/>
            <a:ext cx="1281953" cy="26240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E12434F-91DD-40FD-B052-82876FB0CE0A}"/>
              </a:ext>
            </a:extLst>
          </p:cNvPr>
          <p:cNvSpPr txBox="1"/>
          <p:nvPr/>
        </p:nvSpPr>
        <p:spPr>
          <a:xfrm>
            <a:off x="8934714" y="5040310"/>
            <a:ext cx="824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6F41ADD-CB11-4174-B22E-50BE1A7CE784}"/>
              </a:ext>
            </a:extLst>
          </p:cNvPr>
          <p:cNvCxnSpPr>
            <a:cxnSpLocks/>
          </p:cNvCxnSpPr>
          <p:nvPr/>
        </p:nvCxnSpPr>
        <p:spPr>
          <a:xfrm>
            <a:off x="557590" y="1558178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F149C707-0C0D-4F9E-917E-7E21AC402F33}"/>
              </a:ext>
            </a:extLst>
          </p:cNvPr>
          <p:cNvCxnSpPr>
            <a:cxnSpLocks/>
          </p:cNvCxnSpPr>
          <p:nvPr/>
        </p:nvCxnSpPr>
        <p:spPr>
          <a:xfrm>
            <a:off x="1167192" y="1563932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784862A7-A003-4B98-9DE6-84B0A750E7E1}"/>
              </a:ext>
            </a:extLst>
          </p:cNvPr>
          <p:cNvSpPr txBox="1"/>
          <p:nvPr/>
        </p:nvSpPr>
        <p:spPr>
          <a:xfrm>
            <a:off x="4400809" y="174962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87AA09E-3215-4C60-9CD3-6520D73BFD0A}"/>
              </a:ext>
            </a:extLst>
          </p:cNvPr>
          <p:cNvSpPr txBox="1"/>
          <p:nvPr/>
        </p:nvSpPr>
        <p:spPr>
          <a:xfrm>
            <a:off x="4971341" y="1736447"/>
            <a:ext cx="580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UR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86E01DBA-E02A-417A-871B-D1C6E79FA29A}"/>
              </a:ext>
            </a:extLst>
          </p:cNvPr>
          <p:cNvCxnSpPr>
            <a:cxnSpLocks/>
          </p:cNvCxnSpPr>
          <p:nvPr/>
        </p:nvCxnSpPr>
        <p:spPr>
          <a:xfrm>
            <a:off x="4374931" y="1753699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64A2B913-7B98-461B-B782-9C6129ACC14A}"/>
              </a:ext>
            </a:extLst>
          </p:cNvPr>
          <p:cNvCxnSpPr>
            <a:cxnSpLocks/>
          </p:cNvCxnSpPr>
          <p:nvPr/>
        </p:nvCxnSpPr>
        <p:spPr>
          <a:xfrm>
            <a:off x="4984533" y="1750827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7EA0CB44-CD78-4690-8D1D-D80A85CC620F}"/>
              </a:ext>
            </a:extLst>
          </p:cNvPr>
          <p:cNvSpPr txBox="1"/>
          <p:nvPr/>
        </p:nvSpPr>
        <p:spPr>
          <a:xfrm>
            <a:off x="8898143" y="105879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25BBFBB-5B34-4F25-838D-175EED6B68F8}"/>
              </a:ext>
            </a:extLst>
          </p:cNvPr>
          <p:cNvSpPr txBox="1"/>
          <p:nvPr/>
        </p:nvSpPr>
        <p:spPr>
          <a:xfrm>
            <a:off x="9468675" y="1045616"/>
            <a:ext cx="580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UR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40ACE2E0-533E-4E2D-BAD9-636210D63054}"/>
              </a:ext>
            </a:extLst>
          </p:cNvPr>
          <p:cNvCxnSpPr>
            <a:cxnSpLocks/>
          </p:cNvCxnSpPr>
          <p:nvPr/>
        </p:nvCxnSpPr>
        <p:spPr>
          <a:xfrm>
            <a:off x="8872265" y="1062868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62370A47-FC19-4EBA-83F2-1237D8277235}"/>
              </a:ext>
            </a:extLst>
          </p:cNvPr>
          <p:cNvCxnSpPr>
            <a:cxnSpLocks/>
          </p:cNvCxnSpPr>
          <p:nvPr/>
        </p:nvCxnSpPr>
        <p:spPr>
          <a:xfrm>
            <a:off x="9481867" y="1059996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330468E6-62FA-4474-896B-31191C61AE80}"/>
              </a:ext>
            </a:extLst>
          </p:cNvPr>
          <p:cNvSpPr txBox="1"/>
          <p:nvPr/>
        </p:nvSpPr>
        <p:spPr>
          <a:xfrm>
            <a:off x="1315345" y="5429984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5C8CF65-1A90-42D3-AF87-8494EBB515D3}"/>
              </a:ext>
            </a:extLst>
          </p:cNvPr>
          <p:cNvSpPr txBox="1"/>
          <p:nvPr/>
        </p:nvSpPr>
        <p:spPr>
          <a:xfrm>
            <a:off x="1885877" y="5416802"/>
            <a:ext cx="580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UR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5FFF8222-F445-4205-B16F-9B6BD3B182D3}"/>
              </a:ext>
            </a:extLst>
          </p:cNvPr>
          <p:cNvCxnSpPr>
            <a:cxnSpLocks/>
          </p:cNvCxnSpPr>
          <p:nvPr/>
        </p:nvCxnSpPr>
        <p:spPr>
          <a:xfrm>
            <a:off x="1289467" y="5434054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BB0A4620-6AC7-4961-8AC8-35EB34FBFC84}"/>
              </a:ext>
            </a:extLst>
          </p:cNvPr>
          <p:cNvCxnSpPr>
            <a:cxnSpLocks/>
          </p:cNvCxnSpPr>
          <p:nvPr/>
        </p:nvCxnSpPr>
        <p:spPr>
          <a:xfrm>
            <a:off x="1899069" y="5431182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E4FF014E-BA63-4165-91DB-DA0428D52CC8}"/>
              </a:ext>
            </a:extLst>
          </p:cNvPr>
          <p:cNvSpPr txBox="1"/>
          <p:nvPr/>
        </p:nvSpPr>
        <p:spPr>
          <a:xfrm>
            <a:off x="5235164" y="5542031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BF13F0E-1C75-45F9-BD84-64FF6DE81E87}"/>
              </a:ext>
            </a:extLst>
          </p:cNvPr>
          <p:cNvSpPr txBox="1"/>
          <p:nvPr/>
        </p:nvSpPr>
        <p:spPr>
          <a:xfrm>
            <a:off x="5805696" y="5528849"/>
            <a:ext cx="580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UR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72AB0C3E-95C5-4027-B9C3-6CD07591F940}"/>
              </a:ext>
            </a:extLst>
          </p:cNvPr>
          <p:cNvCxnSpPr>
            <a:cxnSpLocks/>
          </p:cNvCxnSpPr>
          <p:nvPr/>
        </p:nvCxnSpPr>
        <p:spPr>
          <a:xfrm>
            <a:off x="5209286" y="5546101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1A1EEC15-9B33-46DA-87C9-96B4FC077414}"/>
              </a:ext>
            </a:extLst>
          </p:cNvPr>
          <p:cNvCxnSpPr>
            <a:cxnSpLocks/>
          </p:cNvCxnSpPr>
          <p:nvPr/>
        </p:nvCxnSpPr>
        <p:spPr>
          <a:xfrm>
            <a:off x="5818888" y="5543229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73E99758-6C44-4F25-880B-48E3355F7E9F}"/>
              </a:ext>
            </a:extLst>
          </p:cNvPr>
          <p:cNvSpPr txBox="1"/>
          <p:nvPr/>
        </p:nvSpPr>
        <p:spPr>
          <a:xfrm>
            <a:off x="9024883" y="574933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AA15387-67F4-41FD-958C-CA5D5FD001A2}"/>
              </a:ext>
            </a:extLst>
          </p:cNvPr>
          <p:cNvSpPr txBox="1"/>
          <p:nvPr/>
        </p:nvSpPr>
        <p:spPr>
          <a:xfrm>
            <a:off x="9595415" y="5736156"/>
            <a:ext cx="5806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UR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0BD3961C-62F6-491F-87A3-A447E1220B2F}"/>
              </a:ext>
            </a:extLst>
          </p:cNvPr>
          <p:cNvCxnSpPr>
            <a:cxnSpLocks/>
          </p:cNvCxnSpPr>
          <p:nvPr/>
        </p:nvCxnSpPr>
        <p:spPr>
          <a:xfrm>
            <a:off x="8999005" y="5753408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9D0508DB-205C-4E70-A00F-01C475F574A7}"/>
              </a:ext>
            </a:extLst>
          </p:cNvPr>
          <p:cNvCxnSpPr>
            <a:cxnSpLocks/>
          </p:cNvCxnSpPr>
          <p:nvPr/>
        </p:nvCxnSpPr>
        <p:spPr>
          <a:xfrm>
            <a:off x="9608607" y="5750536"/>
            <a:ext cx="5650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8715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32</Words>
  <Application>Microsoft Office PowerPoint</Application>
  <PresentationFormat>Widescreen</PresentationFormat>
  <Paragraphs>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Irene</dc:creator>
  <cp:lastModifiedBy>Kim, Yoo</cp:lastModifiedBy>
  <cp:revision>8</cp:revision>
  <dcterms:created xsi:type="dcterms:W3CDTF">2024-04-29T20:49:49Z</dcterms:created>
  <dcterms:modified xsi:type="dcterms:W3CDTF">2024-06-22T03:46:25Z</dcterms:modified>
</cp:coreProperties>
</file>